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76" r:id="rId2"/>
    <p:sldId id="279" r:id="rId3"/>
    <p:sldId id="261" r:id="rId4"/>
    <p:sldId id="278" r:id="rId5"/>
    <p:sldId id="270" r:id="rId6"/>
    <p:sldId id="271" r:id="rId7"/>
    <p:sldId id="273" r:id="rId8"/>
    <p:sldId id="27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56" autoAdjust="0"/>
    <p:restoredTop sz="94660"/>
  </p:normalViewPr>
  <p:slideViewPr>
    <p:cSldViewPr snapToGrid="0">
      <p:cViewPr>
        <p:scale>
          <a:sx n="66" d="100"/>
          <a:sy n="66" d="100"/>
        </p:scale>
        <p:origin x="12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5738F8-5F9D-4089-8545-B3E3D458FE44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E79B31-F47B-43B5-974D-B0FCB9B53B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48538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63611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67777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9570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6506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0746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19222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98377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18456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15213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59720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56852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D0C3C-BC49-4C73-87C6-05998804C479}" type="datetimeFigureOut">
              <a:rPr lang="en-IN" smtClean="0"/>
              <a:t>12-03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974EE7-3B2E-4C51-B48D-921C881AA59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65111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482709" y="234981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8" name="Rectangle 7"/>
          <p:cNvSpPr>
            <a:spLocks noChangeArrowheads="1"/>
          </p:cNvSpPr>
          <p:nvPr/>
        </p:nvSpPr>
        <p:spPr bwMode="auto">
          <a:xfrm>
            <a:off x="5860143" y="296918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>
                <a:latin typeface="Arial" panose="020B0604020202020204" pitchFamily="34" charset="0"/>
              </a:rPr>
              <a:t>B</a:t>
            </a:r>
            <a:endParaRPr kumimoji="0" lang="en-US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743" y="573535"/>
            <a:ext cx="5486400" cy="54864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7141" y="589177"/>
            <a:ext cx="5486400" cy="5486400"/>
          </a:xfrm>
          <a:prstGeom prst="rect">
            <a:avLst/>
          </a:prstGeom>
        </p:spPr>
      </p:pic>
      <p:sp>
        <p:nvSpPr>
          <p:cNvPr id="14" name="Rectangle 3"/>
          <p:cNvSpPr>
            <a:spLocks noChangeArrowheads="1"/>
          </p:cNvSpPr>
          <p:nvPr/>
        </p:nvSpPr>
        <p:spPr bwMode="auto">
          <a:xfrm>
            <a:off x="-1211157" y="6519446"/>
            <a:ext cx="14038709" cy="6771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A)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ological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cess,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lecular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unction</a:t>
            </a:r>
            <a:endParaRPr lang="en-US" sz="1200" dirty="0">
              <a:latin typeface="Arial" panose="020B0604020202020204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12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01825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463426" y="292502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 smtClean="0">
                <a:latin typeface="Arial" panose="020B0604020202020204" pitchFamily="34" charset="0"/>
              </a:rPr>
              <a:t>C</a:t>
            </a:r>
            <a:endParaRPr kumimoji="0" lang="en-US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5713855" y="292502"/>
            <a:ext cx="304800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 smtClean="0">
                <a:latin typeface="Arial" panose="020B0604020202020204" pitchFamily="34" charset="0"/>
              </a:rPr>
              <a:t>D</a:t>
            </a:r>
            <a:endParaRPr kumimoji="0" lang="en-US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1056"/>
            <a:ext cx="5486400" cy="5486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6110" y="631056"/>
            <a:ext cx="5486400" cy="5486400"/>
          </a:xfrm>
          <a:prstGeom prst="rect">
            <a:avLst/>
          </a:prstGeom>
        </p:spPr>
      </p:pic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-1211157" y="6427113"/>
            <a:ext cx="14038709" cy="8617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ular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nent,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)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EGG pathwa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1200" dirty="0">
              <a:latin typeface="Arial" panose="020B0604020202020204" pitchFamily="34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12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94526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/>
          </a:p>
        </p:txBody>
      </p:sp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3276599" y="4499011"/>
            <a:ext cx="637540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kumimoji="0" lang="en-US" sz="14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2. A)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uroactive ligand-receptor interaction, B)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opaminergic synapse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751332" y="457200"/>
            <a:ext cx="10689336" cy="3637162"/>
            <a:chOff x="263515" y="191438"/>
            <a:chExt cx="10689336" cy="3637162"/>
          </a:xfrm>
        </p:grpSpPr>
        <p:pic>
          <p:nvPicPr>
            <p:cNvPr id="7169" name="Picture 10" descr="Neuroactive ligand recepator interaction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6824" y="228600"/>
              <a:ext cx="3972857" cy="36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13" descr="Dopaminergic Synapse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87713" y="228600"/>
              <a:ext cx="5565138" cy="36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Rectangle 6"/>
            <p:cNvSpPr>
              <a:spLocks noChangeArrowheads="1"/>
            </p:cNvSpPr>
            <p:nvPr/>
          </p:nvSpPr>
          <p:spPr bwMode="auto">
            <a:xfrm>
              <a:off x="263515" y="191438"/>
              <a:ext cx="304800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A</a:t>
              </a:r>
            </a:p>
          </p:txBody>
        </p:sp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4925997" y="191438"/>
              <a:ext cx="304800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600" b="1" dirty="0">
                  <a:latin typeface="Arial" panose="020B0604020202020204" pitchFamily="34" charset="0"/>
                </a:rPr>
                <a:t>B</a:t>
              </a:r>
              <a:endPara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111623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75" t="7778" r="4590" b="33333"/>
          <a:stretch/>
        </p:blipFill>
        <p:spPr>
          <a:xfrm>
            <a:off x="853440" y="871537"/>
            <a:ext cx="4206240" cy="4038600"/>
          </a:xfrm>
          <a:prstGeom prst="rect">
            <a:avLst/>
          </a:prstGeom>
          <a:ln>
            <a:noFill/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40" t="7500" r="5611" b="35000"/>
          <a:stretch/>
        </p:blipFill>
        <p:spPr>
          <a:xfrm>
            <a:off x="6496049" y="871537"/>
            <a:ext cx="4214191" cy="4038600"/>
          </a:xfrm>
          <a:prstGeom prst="rect">
            <a:avLst/>
          </a:prstGeom>
          <a:ln>
            <a:noFill/>
          </a:ln>
        </p:spPr>
      </p:pic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2729605" y="5980211"/>
            <a:ext cx="673280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kumimoji="0" lang="en-US" sz="14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3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gand-Protein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D interaction diagram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EGCG, B) Standard Clonazepam </a:t>
            </a:r>
            <a:endParaRPr kumimoji="0" lang="en-US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64280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3660816" y="4218800"/>
            <a:ext cx="576258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</a:t>
            </a:r>
            <a:r>
              <a:rPr kumimoji="0" lang="en-US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ein ligand interaction fraction A) EGCG, B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kumimoji="0" lang="en-US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ndard Clonazepam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U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446532" y="558800"/>
            <a:ext cx="11197312" cy="2880000"/>
            <a:chOff x="294132" y="1574800"/>
            <a:chExt cx="11197312" cy="28800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17" t="11644" r="1880" b="52707"/>
            <a:stretch/>
          </p:blipFill>
          <p:spPr>
            <a:xfrm>
              <a:off x="621506" y="1574800"/>
              <a:ext cx="5301818" cy="28800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8" t="11644" r="2763" b="52707"/>
            <a:stretch/>
          </p:blipFill>
          <p:spPr>
            <a:xfrm>
              <a:off x="6357936" y="1574800"/>
              <a:ext cx="5133508" cy="2880000"/>
            </a:xfrm>
            <a:prstGeom prst="rect">
              <a:avLst/>
            </a:prstGeom>
          </p:spPr>
        </p:pic>
        <p:sp>
          <p:nvSpPr>
            <p:cNvPr id="6" name="Rectangle 5"/>
            <p:cNvSpPr>
              <a:spLocks noChangeArrowheads="1"/>
            </p:cNvSpPr>
            <p:nvPr/>
          </p:nvSpPr>
          <p:spPr bwMode="auto">
            <a:xfrm>
              <a:off x="294132" y="1574800"/>
              <a:ext cx="304800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Rectangle 6"/>
            <p:cNvSpPr>
              <a:spLocks noChangeArrowheads="1"/>
            </p:cNvSpPr>
            <p:nvPr/>
          </p:nvSpPr>
          <p:spPr bwMode="auto">
            <a:xfrm>
              <a:off x="5959914" y="1574800"/>
              <a:ext cx="304800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600" b="1" dirty="0">
                  <a:latin typeface="Arial" panose="020B0604020202020204" pitchFamily="34" charset="0"/>
                </a:rPr>
                <a:t>B</a:t>
              </a:r>
              <a:endPara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090220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/>
          </a:p>
        </p:txBody>
      </p:sp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3287445" y="5980211"/>
            <a:ext cx="561711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re </a:t>
            </a:r>
            <a:r>
              <a:rPr kumimoji="0" lang="en-US" sz="14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5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gand-Protein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acts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EGCG, B) Standard Clonazepam </a:t>
            </a:r>
            <a:endParaRPr kumimoji="0" lang="en-US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75" t="11852" r="9671" b="22963"/>
          <a:stretch/>
        </p:blipFill>
        <p:spPr>
          <a:xfrm>
            <a:off x="802229" y="203200"/>
            <a:ext cx="4491543" cy="535940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16" t="12913" r="5050" b="23804"/>
          <a:stretch/>
        </p:blipFill>
        <p:spPr>
          <a:xfrm>
            <a:off x="5969001" y="203200"/>
            <a:ext cx="5140304" cy="5359399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23999913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/>
          <a:stretch>
            <a:fillRect/>
          </a:stretch>
        </p:blipFill>
        <p:spPr>
          <a:xfrm>
            <a:off x="3180826" y="342901"/>
            <a:ext cx="6194549" cy="519941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569549" y="5926379"/>
            <a:ext cx="2788456" cy="3114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6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x of protein</a:t>
            </a:r>
            <a:endParaRPr lang="en-IN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7760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/>
          </a:p>
        </p:txBody>
      </p:sp>
      <p:sp>
        <p:nvSpPr>
          <p:cNvPr id="4" name="Rectangle 5"/>
          <p:cNvSpPr>
            <a:spLocks noChangeArrowheads="1"/>
          </p:cNvSpPr>
          <p:nvPr/>
        </p:nvSpPr>
        <p:spPr bwMode="auto">
          <a:xfrm>
            <a:off x="3671887" y="5413681"/>
            <a:ext cx="1101777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7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gand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perties, A) EGCG, B) Standard Clonazepam </a:t>
            </a:r>
            <a:endParaRPr kumimoji="0" lang="en-US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9" t="7407" r="2338" b="37407"/>
          <a:stretch/>
        </p:blipFill>
        <p:spPr>
          <a:xfrm>
            <a:off x="2117725" y="1050835"/>
            <a:ext cx="4546600" cy="37846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4" t="7639" r="3156" b="37153"/>
          <a:stretch/>
        </p:blipFill>
        <p:spPr>
          <a:xfrm>
            <a:off x="6843713" y="1077358"/>
            <a:ext cx="4429125" cy="3786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0191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</TotalTime>
  <Words>109</Words>
  <Application>Microsoft Office PowerPoint</Application>
  <PresentationFormat>Widescreen</PresentationFormat>
  <Paragraphs>17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Windows User</cp:lastModifiedBy>
  <cp:revision>26</cp:revision>
  <dcterms:created xsi:type="dcterms:W3CDTF">2024-03-08T05:17:25Z</dcterms:created>
  <dcterms:modified xsi:type="dcterms:W3CDTF">2024-03-12T09:39:54Z</dcterms:modified>
</cp:coreProperties>
</file>